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owkat\Dropbox\miRNA%20Wild%20rice%20data\All%20in%20One\miRNA%20Vs%20Proein%20Coding\JC\Jukes-Canter%20Valu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on and Non-con pre-Seqs 10 Sps'!$O$303</c:f>
              <c:strCache>
                <c:ptCount val="1"/>
                <c:pt idx="0">
                  <c:v>AT-content</c:v>
                </c:pt>
              </c:strCache>
            </c:strRef>
          </c:tx>
          <c:invertIfNegative val="0"/>
          <c:cat>
            <c:multiLvlStrRef>
              <c:f>'Con and Non-con pre-Seqs 10 Sps'!$M$304:$N$310</c:f>
              <c:multiLvlStrCache>
                <c:ptCount val="7"/>
                <c:lvl>
                  <c:pt idx="0">
                    <c:v>Mature</c:v>
                  </c:pt>
                  <c:pt idx="1">
                    <c:v>Star</c:v>
                  </c:pt>
                  <c:pt idx="2">
                    <c:v>Precursor</c:v>
                  </c:pt>
                  <c:pt idx="4">
                    <c:v>Mature</c:v>
                  </c:pt>
                  <c:pt idx="5">
                    <c:v>Star</c:v>
                  </c:pt>
                  <c:pt idx="6">
                    <c:v>Precursor</c:v>
                  </c:pt>
                </c:lvl>
                <c:lvl>
                  <c:pt idx="0">
                    <c:v>Conserved</c:v>
                  </c:pt>
                  <c:pt idx="4">
                    <c:v>Nonconserved</c:v>
                  </c:pt>
                </c:lvl>
              </c:multiLvlStrCache>
            </c:multiLvlStrRef>
          </c:cat>
          <c:val>
            <c:numRef>
              <c:f>'Con and Non-con pre-Seqs 10 Sps'!$O$304:$O$310</c:f>
              <c:numCache>
                <c:formatCode>General</c:formatCode>
                <c:ptCount val="7"/>
                <c:pt idx="0">
                  <c:v>10.022220000000001</c:v>
                </c:pt>
                <c:pt idx="1">
                  <c:v>10.035805626598465</c:v>
                </c:pt>
                <c:pt idx="2">
                  <c:v>72.147909967845706</c:v>
                </c:pt>
                <c:pt idx="3">
                  <c:v>0</c:v>
                </c:pt>
                <c:pt idx="4">
                  <c:v>10.151785714285717</c:v>
                </c:pt>
                <c:pt idx="5">
                  <c:v>10.366071428571425</c:v>
                </c:pt>
                <c:pt idx="6">
                  <c:v>77.700892857142833</c:v>
                </c:pt>
              </c:numCache>
            </c:numRef>
          </c:val>
        </c:ser>
        <c:ser>
          <c:idx val="1"/>
          <c:order val="1"/>
          <c:tx>
            <c:strRef>
              <c:f>'Con and Non-con pre-Seqs 10 Sps'!$P$303</c:f>
              <c:strCache>
                <c:ptCount val="1"/>
                <c:pt idx="0">
                  <c:v>GC-content</c:v>
                </c:pt>
              </c:strCache>
            </c:strRef>
          </c:tx>
          <c:invertIfNegative val="0"/>
          <c:cat>
            <c:multiLvlStrRef>
              <c:f>'Con and Non-con pre-Seqs 10 Sps'!$M$304:$N$310</c:f>
              <c:multiLvlStrCache>
                <c:ptCount val="7"/>
                <c:lvl>
                  <c:pt idx="0">
                    <c:v>Mature</c:v>
                  </c:pt>
                  <c:pt idx="1">
                    <c:v>Star</c:v>
                  </c:pt>
                  <c:pt idx="2">
                    <c:v>Precursor</c:v>
                  </c:pt>
                  <c:pt idx="4">
                    <c:v>Mature</c:v>
                  </c:pt>
                  <c:pt idx="5">
                    <c:v>Star</c:v>
                  </c:pt>
                  <c:pt idx="6">
                    <c:v>Precursor</c:v>
                  </c:pt>
                </c:lvl>
                <c:lvl>
                  <c:pt idx="0">
                    <c:v>Conserved</c:v>
                  </c:pt>
                  <c:pt idx="4">
                    <c:v>Nonconserved</c:v>
                  </c:pt>
                </c:lvl>
              </c:multiLvlStrCache>
            </c:multiLvlStrRef>
          </c:cat>
          <c:val>
            <c:numRef>
              <c:f>'Con and Non-con pre-Seqs 10 Sps'!$P$304:$P$310</c:f>
              <c:numCache>
                <c:formatCode>General</c:formatCode>
                <c:ptCount val="7"/>
                <c:pt idx="0">
                  <c:v>11.105793450881615</c:v>
                </c:pt>
                <c:pt idx="1">
                  <c:v>11.12531969309463</c:v>
                </c:pt>
                <c:pt idx="2">
                  <c:v>73.176848874597979</c:v>
                </c:pt>
                <c:pt idx="3">
                  <c:v>0</c:v>
                </c:pt>
                <c:pt idx="4">
                  <c:v>12.053571428571425</c:v>
                </c:pt>
                <c:pt idx="5">
                  <c:v>11.611607142857141</c:v>
                </c:pt>
                <c:pt idx="6">
                  <c:v>63.4196428571428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0430592"/>
        <c:axId val="80432128"/>
      </c:barChart>
      <c:catAx>
        <c:axId val="804305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100" b="1"/>
            </a:pPr>
            <a:endParaRPr lang="en-US"/>
          </a:p>
        </c:txPr>
        <c:crossAx val="80432128"/>
        <c:crosses val="autoZero"/>
        <c:auto val="1"/>
        <c:lblAlgn val="ctr"/>
        <c:lblOffset val="100"/>
        <c:noMultiLvlLbl val="0"/>
      </c:catAx>
      <c:valAx>
        <c:axId val="804321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80430592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676400" y="304800"/>
            <a:ext cx="5715000" cy="5488125"/>
            <a:chOff x="1676400" y="1219201"/>
            <a:chExt cx="5715000" cy="5488125"/>
          </a:xfrm>
        </p:grpSpPr>
        <p:sp>
          <p:nvSpPr>
            <p:cNvPr id="6" name="Rectangle 5"/>
            <p:cNvSpPr/>
            <p:nvPr/>
          </p:nvSpPr>
          <p:spPr>
            <a:xfrm>
              <a:off x="1676400" y="4953000"/>
              <a:ext cx="5715000" cy="175432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IN" b="1" smtClean="0">
                  <a:latin typeface="Times New Roman" pitchFamily="18" charset="0"/>
                  <a:cs typeface="Times New Roman" pitchFamily="18" charset="0"/>
                </a:rPr>
                <a:t>Figure </a:t>
              </a:r>
              <a:r>
                <a:rPr lang="en-IN" b="1" dirty="0" smtClean="0">
                  <a:latin typeface="Times New Roman" pitchFamily="18" charset="0"/>
                  <a:cs typeface="Times New Roman" pitchFamily="18" charset="0"/>
                </a:rPr>
                <a:t>S4. </a:t>
              </a:r>
              <a:r>
                <a:rPr lang="en-IN" dirty="0">
                  <a:latin typeface="Times New Roman" pitchFamily="18" charset="0"/>
                  <a:cs typeface="Times New Roman" pitchFamily="18" charset="0"/>
                </a:rPr>
                <a:t>R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elation </a:t>
              </a:r>
              <a:r>
                <a:rPr lang="en-IN" dirty="0">
                  <a:latin typeface="Times New Roman" pitchFamily="18" charset="0"/>
                  <a:cs typeface="Times New Roman" pitchFamily="18" charset="0"/>
                </a:rPr>
                <a:t>between the base content of </a:t>
              </a:r>
              <a:r>
                <a:rPr lang="en-IN" dirty="0" err="1">
                  <a:latin typeface="Times New Roman" pitchFamily="18" charset="0"/>
                  <a:cs typeface="Times New Roman" pitchFamily="18" charset="0"/>
                </a:rPr>
                <a:t>miRNA</a:t>
              </a:r>
              <a:r>
                <a:rPr lang="en-IN" dirty="0">
                  <a:latin typeface="Times New Roman" pitchFamily="18" charset="0"/>
                  <a:cs typeface="Times New Roman" pitchFamily="18" charset="0"/>
                </a:rPr>
                <a:t> genes and their 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conservation</a:t>
              </a:r>
              <a:r>
                <a:rPr lang="en-IN" dirty="0">
                  <a:latin typeface="Times New Roman" pitchFamily="18" charset="0"/>
                  <a:cs typeface="Times New Roman" pitchFamily="18" charset="0"/>
                </a:rPr>
                <a:t>. 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AT-content can be seen as </a:t>
              </a:r>
              <a:r>
                <a:rPr lang="en-IN" dirty="0">
                  <a:latin typeface="Times New Roman" pitchFamily="18" charset="0"/>
                  <a:cs typeface="Times New Roman" pitchFamily="18" charset="0"/>
                </a:rPr>
                <a:t>lesser than 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GC-content </a:t>
              </a:r>
              <a:r>
                <a:rPr lang="en-IN" dirty="0">
                  <a:latin typeface="Times New Roman" pitchFamily="18" charset="0"/>
                  <a:cs typeface="Times New Roman" pitchFamily="18" charset="0"/>
                </a:rPr>
                <a:t>in mature and star regions of both conserved as well as non-conserved </a:t>
              </a:r>
              <a:r>
                <a:rPr lang="en-IN" dirty="0" err="1">
                  <a:latin typeface="Times New Roman" pitchFamily="18" charset="0"/>
                  <a:cs typeface="Times New Roman" pitchFamily="18" charset="0"/>
                </a:rPr>
                <a:t>miRNA</a:t>
              </a:r>
              <a:r>
                <a:rPr lang="en-IN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genes. It also depicts that AT-content in non-conserved </a:t>
              </a:r>
              <a:r>
                <a:rPr lang="en-IN" dirty="0" err="1" smtClean="0">
                  <a:latin typeface="Times New Roman" pitchFamily="18" charset="0"/>
                  <a:cs typeface="Times New Roman" pitchFamily="18" charset="0"/>
                </a:rPr>
                <a:t>miRNA</a:t>
              </a:r>
              <a:r>
                <a:rPr lang="en-IN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precursors is higher than the conserved ones.</a:t>
              </a:r>
              <a:endParaRPr lang="en-IN" dirty="0">
                <a:latin typeface="Times New Roman" pitchFamily="18" charset="0"/>
                <a:cs typeface="Times New Roman" pitchFamily="18" charset="0"/>
              </a:endParaRPr>
            </a:p>
          </p:txBody>
        </p:sp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86947064"/>
                </p:ext>
              </p:extLst>
            </p:nvPr>
          </p:nvGraphicFramePr>
          <p:xfrm>
            <a:off x="1981200" y="1219201"/>
            <a:ext cx="5410199" cy="34075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904565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owkat</dc:creator>
  <cp:lastModifiedBy>Balindan, Danica Joy</cp:lastModifiedBy>
  <cp:revision>8</cp:revision>
  <dcterms:created xsi:type="dcterms:W3CDTF">2006-08-16T00:00:00Z</dcterms:created>
  <dcterms:modified xsi:type="dcterms:W3CDTF">2017-08-30T15:16:15Z</dcterms:modified>
</cp:coreProperties>
</file>